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4EBA693-1D65-41A4-866C-B1AE0ECD125B}" v="1" dt="2025-01-21T13:26:40.16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cute kidney injury in paediatric kidney transplant recipient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ohidin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and Marks,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Early detection and assessment of AKI is crucial in promoting recovery. Research into identifying AKI biomarkers to assist early diagnosis, before the serum creatinine rises, is ongoing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250371" y="1258206"/>
            <a:ext cx="5988060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1. Acute kidney injury is common post-transplant and causes can be categorised into pre-kidney, intrinsic kidney, and post-kidney headings.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2. Percutaneous kidney transplant biopsy is key to assisting diagnosis in acute kidney injury.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3. Thrombotic microangiopathy has a wide differential diagnosis post-transplantation.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4. Recurrent urinary tract infections and allograft dysfunction should prompt further investigation into identifying a pre-disposing factor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DD50349-C762-6D5A-8DAC-596B62941A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0005509"/>
              </p:ext>
            </p:extLst>
          </p:nvPr>
        </p:nvGraphicFramePr>
        <p:xfrm>
          <a:off x="6310475" y="1906487"/>
          <a:ext cx="5725160" cy="3379888"/>
        </p:xfrm>
        <a:graphic>
          <a:graphicData uri="http://schemas.openxmlformats.org/drawingml/2006/table">
            <a:tbl>
              <a:tblPr firstRow="1" firstCol="1" bandRow="1">
                <a:tableStyleId>{46F890A9-2807-4EBB-B81D-B2AA78EC7F39}</a:tableStyleId>
              </a:tblPr>
              <a:tblGrid>
                <a:gridCol w="1800225">
                  <a:extLst>
                    <a:ext uri="{9D8B030D-6E8A-4147-A177-3AD203B41FA5}">
                      <a16:colId xmlns:a16="http://schemas.microsoft.com/office/drawing/2014/main" val="3185947137"/>
                    </a:ext>
                  </a:extLst>
                </a:gridCol>
                <a:gridCol w="1980565">
                  <a:extLst>
                    <a:ext uri="{9D8B030D-6E8A-4147-A177-3AD203B41FA5}">
                      <a16:colId xmlns:a16="http://schemas.microsoft.com/office/drawing/2014/main" val="228232594"/>
                    </a:ext>
                  </a:extLst>
                </a:gridCol>
                <a:gridCol w="1944370">
                  <a:extLst>
                    <a:ext uri="{9D8B030D-6E8A-4147-A177-3AD203B41FA5}">
                      <a16:colId xmlns:a16="http://schemas.microsoft.com/office/drawing/2014/main" val="267743529"/>
                    </a:ext>
                  </a:extLst>
                </a:gridCol>
              </a:tblGrid>
              <a:tr h="70675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Immediate (0 – 1 week post-transplantation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Early (1 week – 6 months post-transplantation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Late (&gt;6 months post-transplantation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377119282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Acute tubular injury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Infection 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Infe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724587359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Hypovolaemia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Acute reje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Chronic reje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437104071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Obstru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Calcineurin inhibitor toxicity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Acute reje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180495780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Urinary leak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Acute tubular injury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Calcineurin inhibitor toxicity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896541713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Renal vein thrombosis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Obstru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Obstru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228129061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Renal artery thrombosis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Urinary leak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Recurrent disease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281497523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Hyperacute rejection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Recurrent disease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De novo kidney disease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780812244"/>
                  </a:ext>
                </a:extLst>
              </a:tr>
              <a:tr h="33414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 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 </a:t>
                      </a:r>
                      <a:r>
                        <a:rPr lang="en-GB" sz="1100" b="0" kern="100" dirty="0">
                          <a:solidFill>
                            <a:srgbClr val="003969"/>
                          </a:solidFill>
                          <a:effectLst/>
                        </a:rPr>
                        <a:t>Thrombotic microangiopathy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0" kern="100" dirty="0">
                          <a:solidFill>
                            <a:srgbClr val="003969"/>
                          </a:solidFill>
                          <a:effectLst/>
                        </a:rPr>
                        <a:t>Thrombotic microangiopathy</a:t>
                      </a:r>
                      <a:endParaRPr lang="en-GB" sz="1100" b="0" kern="100" dirty="0">
                        <a:solidFill>
                          <a:srgbClr val="003969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657929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93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1-21T13:30:51Z</dcterms:modified>
</cp:coreProperties>
</file>